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  <p:sldId id="260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25" autoAdjust="0"/>
    <p:restoredTop sz="94660"/>
  </p:normalViewPr>
  <p:slideViewPr>
    <p:cSldViewPr snapToGrid="0">
      <p:cViewPr varScale="1">
        <p:scale>
          <a:sx n="101" d="100"/>
          <a:sy n="101" d="100"/>
        </p:scale>
        <p:origin x="14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77E84-A6A6-442C-93F5-D080FE3CE161}" type="datetimeFigureOut">
              <a:rPr lang="en-US" smtClean="0"/>
              <a:t>3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6FEA4-2C64-436E-AAFB-B4417BBDDF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40905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77E84-A6A6-442C-93F5-D080FE3CE161}" type="datetimeFigureOut">
              <a:rPr lang="en-US" smtClean="0"/>
              <a:t>3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6FEA4-2C64-436E-AAFB-B4417BBDDF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41524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77E84-A6A6-442C-93F5-D080FE3CE161}" type="datetimeFigureOut">
              <a:rPr lang="en-US" smtClean="0"/>
              <a:t>3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6FEA4-2C64-436E-AAFB-B4417BBDDF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94851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77E84-A6A6-442C-93F5-D080FE3CE161}" type="datetimeFigureOut">
              <a:rPr lang="en-US" smtClean="0"/>
              <a:t>3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6FEA4-2C64-436E-AAFB-B4417BBDDF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97410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77E84-A6A6-442C-93F5-D080FE3CE161}" type="datetimeFigureOut">
              <a:rPr lang="en-US" smtClean="0"/>
              <a:t>3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6FEA4-2C64-436E-AAFB-B4417BBDDF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1776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77E84-A6A6-442C-93F5-D080FE3CE161}" type="datetimeFigureOut">
              <a:rPr lang="en-US" smtClean="0"/>
              <a:t>3/1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6FEA4-2C64-436E-AAFB-B4417BBDDF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34494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77E84-A6A6-442C-93F5-D080FE3CE161}" type="datetimeFigureOut">
              <a:rPr lang="en-US" smtClean="0"/>
              <a:t>3/14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6FEA4-2C64-436E-AAFB-B4417BBDDF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94606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77E84-A6A6-442C-93F5-D080FE3CE161}" type="datetimeFigureOut">
              <a:rPr lang="en-US" smtClean="0"/>
              <a:t>3/14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6FEA4-2C64-436E-AAFB-B4417BBDDF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57585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77E84-A6A6-442C-93F5-D080FE3CE161}" type="datetimeFigureOut">
              <a:rPr lang="en-US" smtClean="0"/>
              <a:t>3/14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6FEA4-2C64-436E-AAFB-B4417BBDDF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01920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77E84-A6A6-442C-93F5-D080FE3CE161}" type="datetimeFigureOut">
              <a:rPr lang="en-US" smtClean="0"/>
              <a:t>3/1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6FEA4-2C64-436E-AAFB-B4417BBDDF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59953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77E84-A6A6-442C-93F5-D080FE3CE161}" type="datetimeFigureOut">
              <a:rPr lang="en-US" smtClean="0"/>
              <a:t>3/1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6FEA4-2C64-436E-AAFB-B4417BBDDF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0374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077E84-A6A6-442C-93F5-D080FE3CE161}" type="datetimeFigureOut">
              <a:rPr lang="en-US" smtClean="0"/>
              <a:t>3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26FEA4-2C64-436E-AAFB-B4417BBDDF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10900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2E369646-138D-4C8E-9C9B-FDECCFC1CFF1}"/>
              </a:ext>
            </a:extLst>
          </p:cNvPr>
          <p:cNvGrpSpPr/>
          <p:nvPr/>
        </p:nvGrpSpPr>
        <p:grpSpPr>
          <a:xfrm>
            <a:off x="421484" y="812801"/>
            <a:ext cx="10665616" cy="5530849"/>
            <a:chOff x="392909" y="431801"/>
            <a:chExt cx="11195142" cy="6075680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2"/>
            <a:srcRect t="-892"/>
            <a:stretch/>
          </p:blipFill>
          <p:spPr>
            <a:xfrm>
              <a:off x="392909" y="431801"/>
              <a:ext cx="11033145" cy="6075680"/>
            </a:xfrm>
            <a:prstGeom prst="rect">
              <a:avLst/>
            </a:prstGeom>
          </p:spPr>
        </p:pic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B45F7B55-1E8B-4E27-8B21-D33D14C54250}"/>
                </a:ext>
              </a:extLst>
            </p:cNvPr>
            <p:cNvSpPr/>
            <p:nvPr/>
          </p:nvSpPr>
          <p:spPr>
            <a:xfrm>
              <a:off x="392909" y="469900"/>
              <a:ext cx="1651791" cy="1778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45717B6C-0DC8-438B-AE95-9AF75417C78B}"/>
                </a:ext>
              </a:extLst>
            </p:cNvPr>
            <p:cNvSpPr/>
            <p:nvPr/>
          </p:nvSpPr>
          <p:spPr>
            <a:xfrm>
              <a:off x="10998200" y="558800"/>
              <a:ext cx="589851" cy="1778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830B4D71-4B16-41D7-9B67-95461582238A}"/>
              </a:ext>
            </a:extLst>
          </p:cNvPr>
          <p:cNvSpPr txBox="1"/>
          <p:nvPr/>
        </p:nvSpPr>
        <p:spPr>
          <a:xfrm>
            <a:off x="4940936" y="6343650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/z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13FBFC3-7C04-477D-8B8B-EAB5474FEB44}"/>
              </a:ext>
            </a:extLst>
          </p:cNvPr>
          <p:cNvSpPr txBox="1"/>
          <p:nvPr/>
        </p:nvSpPr>
        <p:spPr>
          <a:xfrm>
            <a:off x="4645395" y="812801"/>
            <a:ext cx="64417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. 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negative mode DART-MS spectra for sweet chocolate pepper cultivar.  </a:t>
            </a:r>
          </a:p>
        </p:txBody>
      </p:sp>
    </p:spTree>
    <p:extLst>
      <p:ext uri="{BB962C8B-B14F-4D97-AF65-F5344CB8AC3E}">
        <p14:creationId xmlns:p14="http://schemas.microsoft.com/office/powerpoint/2010/main" val="30392378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Group 25">
            <a:extLst>
              <a:ext uri="{FF2B5EF4-FFF2-40B4-BE49-F238E27FC236}">
                <a16:creationId xmlns:a16="http://schemas.microsoft.com/office/drawing/2014/main" id="{83707CA2-21F9-4D02-B5E9-EAB6C274560D}"/>
              </a:ext>
            </a:extLst>
          </p:cNvPr>
          <p:cNvGrpSpPr/>
          <p:nvPr/>
        </p:nvGrpSpPr>
        <p:grpSpPr>
          <a:xfrm>
            <a:off x="221631" y="219641"/>
            <a:ext cx="9615598" cy="6622574"/>
            <a:chOff x="221631" y="219641"/>
            <a:chExt cx="9615598" cy="6622574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t="3529"/>
            <a:stretch/>
          </p:blipFill>
          <p:spPr>
            <a:xfrm>
              <a:off x="221631" y="447675"/>
              <a:ext cx="4681382" cy="2447926"/>
            </a:xfrm>
            <a:prstGeom prst="rect">
              <a:avLst/>
            </a:prstGeom>
          </p:spPr>
        </p:pic>
        <p:sp>
          <p:nvSpPr>
            <p:cNvPr id="3" name="TextBox 2"/>
            <p:cNvSpPr txBox="1"/>
            <p:nvPr/>
          </p:nvSpPr>
          <p:spPr>
            <a:xfrm>
              <a:off x="2185222" y="439887"/>
              <a:ext cx="148598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umaric acid</a:t>
              </a:r>
            </a:p>
          </p:txBody>
        </p:sp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3"/>
            <a:srcRect t="3524" b="1"/>
            <a:stretch/>
          </p:blipFill>
          <p:spPr>
            <a:xfrm>
              <a:off x="4953000" y="402376"/>
              <a:ext cx="4767782" cy="24932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7190800" y="458700"/>
              <a:ext cx="141384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scorbic acid</a:t>
              </a:r>
            </a:p>
          </p:txBody>
        </p:sp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4"/>
            <a:srcRect t="2818"/>
            <a:stretch/>
          </p:blipFill>
          <p:spPr>
            <a:xfrm>
              <a:off x="221631" y="3878580"/>
              <a:ext cx="4987643" cy="2627263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4626977" y="5092700"/>
              <a:ext cx="106516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apsaicin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CDBCB246-74A9-43A9-B0C8-A6C6C1FEC58B}"/>
                </a:ext>
              </a:extLst>
            </p:cNvPr>
            <p:cNvSpPr txBox="1"/>
            <p:nvPr/>
          </p:nvSpPr>
          <p:spPr>
            <a:xfrm>
              <a:off x="6799564" y="219641"/>
              <a:ext cx="537327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175.1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84D24BA0-44FC-417C-A9C9-000E0BCEB186}"/>
                </a:ext>
              </a:extLst>
            </p:cNvPr>
            <p:cNvSpPr txBox="1"/>
            <p:nvPr/>
          </p:nvSpPr>
          <p:spPr>
            <a:xfrm>
              <a:off x="1863725" y="286148"/>
              <a:ext cx="537327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163.1</a:t>
              </a:r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252FA5C3-80D8-4322-8F43-19F52469990C}"/>
                </a:ext>
              </a:extLst>
            </p:cNvPr>
            <p:cNvSpPr/>
            <p:nvPr/>
          </p:nvSpPr>
          <p:spPr>
            <a:xfrm>
              <a:off x="4727575" y="419100"/>
              <a:ext cx="225425" cy="7302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D052B10F-51ED-44C6-BF9A-3EE2A54F787D}"/>
                </a:ext>
              </a:extLst>
            </p:cNvPr>
            <p:cNvSpPr txBox="1"/>
            <p:nvPr/>
          </p:nvSpPr>
          <p:spPr>
            <a:xfrm>
              <a:off x="4668741" y="5400249"/>
              <a:ext cx="54053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304.3</a:t>
              </a:r>
            </a:p>
          </p:txBody>
        </p:sp>
        <p:cxnSp>
          <p:nvCxnSpPr>
            <p:cNvPr id="13" name="Straight Arrow Connector 12">
              <a:extLst>
                <a:ext uri="{FF2B5EF4-FFF2-40B4-BE49-F238E27FC236}">
                  <a16:creationId xmlns:a16="http://schemas.microsoft.com/office/drawing/2014/main" id="{5A28F337-7D05-4398-88AA-56E74E889D3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683048" y="5629797"/>
              <a:ext cx="211433" cy="94902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7" name="Straight Arrow Connector 16">
              <a:extLst>
                <a:ext uri="{FF2B5EF4-FFF2-40B4-BE49-F238E27FC236}">
                  <a16:creationId xmlns:a16="http://schemas.microsoft.com/office/drawing/2014/main" id="{B7C72962-21F9-4A64-AB18-DF70AD3D5BBD}"/>
                </a:ext>
              </a:extLst>
            </p:cNvPr>
            <p:cNvCxnSpPr/>
            <p:nvPr/>
          </p:nvCxnSpPr>
          <p:spPr>
            <a:xfrm flipH="1">
              <a:off x="2185222" y="809219"/>
              <a:ext cx="530230" cy="16233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" name="Straight Arrow Connector 17">
              <a:extLst>
                <a:ext uri="{FF2B5EF4-FFF2-40B4-BE49-F238E27FC236}">
                  <a16:creationId xmlns:a16="http://schemas.microsoft.com/office/drawing/2014/main" id="{F2F2B33F-1303-4B2D-A5C0-6FB18F8F93E8}"/>
                </a:ext>
              </a:extLst>
            </p:cNvPr>
            <p:cNvCxnSpPr/>
            <p:nvPr/>
          </p:nvCxnSpPr>
          <p:spPr>
            <a:xfrm flipH="1">
              <a:off x="7200761" y="812792"/>
              <a:ext cx="530230" cy="16233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AF57C9A1-D928-42AC-8EB6-E6276872C448}"/>
                </a:ext>
              </a:extLst>
            </p:cNvPr>
            <p:cNvSpPr txBox="1"/>
            <p:nvPr/>
          </p:nvSpPr>
          <p:spPr>
            <a:xfrm>
              <a:off x="272978" y="279400"/>
              <a:ext cx="2667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A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3C636B3A-13A7-4DCE-A834-5ECBDA8E3051}"/>
                </a:ext>
              </a:extLst>
            </p:cNvPr>
            <p:cNvSpPr txBox="1"/>
            <p:nvPr/>
          </p:nvSpPr>
          <p:spPr>
            <a:xfrm>
              <a:off x="5050050" y="279400"/>
              <a:ext cx="2667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B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BF611EF2-0D25-4BC4-88C0-C6DCB9453340}"/>
                </a:ext>
              </a:extLst>
            </p:cNvPr>
            <p:cNvSpPr txBox="1"/>
            <p:nvPr/>
          </p:nvSpPr>
          <p:spPr>
            <a:xfrm>
              <a:off x="272978" y="3805555"/>
              <a:ext cx="2667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C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5A142653-272B-436B-85AC-E85DE75EED93}"/>
                </a:ext>
              </a:extLst>
            </p:cNvPr>
            <p:cNvSpPr txBox="1"/>
            <p:nvPr/>
          </p:nvSpPr>
          <p:spPr>
            <a:xfrm>
              <a:off x="2359662" y="6472883"/>
              <a:ext cx="55015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m/z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7256923F-49EB-41BE-B926-1E27033243BF}"/>
                </a:ext>
              </a:extLst>
            </p:cNvPr>
            <p:cNvSpPr txBox="1"/>
            <p:nvPr/>
          </p:nvSpPr>
          <p:spPr>
            <a:xfrm>
              <a:off x="2359661" y="2931538"/>
              <a:ext cx="55015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m/z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4CF4A341-4AFB-42BC-8AC8-CBAEB5C91A21}"/>
                </a:ext>
              </a:extLst>
            </p:cNvPr>
            <p:cNvSpPr txBox="1"/>
            <p:nvPr/>
          </p:nvSpPr>
          <p:spPr>
            <a:xfrm>
              <a:off x="6915725" y="2931538"/>
              <a:ext cx="55015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m/z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36BF12B3-7718-4107-9DDE-321915DEEB82}"/>
                </a:ext>
              </a:extLst>
            </p:cNvPr>
            <p:cNvSpPr txBox="1"/>
            <p:nvPr/>
          </p:nvSpPr>
          <p:spPr>
            <a:xfrm>
              <a:off x="5733904" y="3459885"/>
              <a:ext cx="4103325" cy="25853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l Figure 2.  </a:t>
              </a:r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resentative DART-MS spectra (negative mode) for authentic standards of A.) coumaric acid, B.) ascorbic acid, and C.) capsaicin.  Spectra were collected by sampling a 10mg/mL solution in water with the </a:t>
              </a:r>
              <a:r>
                <a:rPr lang="en-US" sz="18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DIP-IT™ method.  DART-MS acquisition settings were identical to those used for pepper standards.</a:t>
              </a:r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311054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1DD397D7-826B-41CB-AF1B-F199AF69C428}"/>
              </a:ext>
            </a:extLst>
          </p:cNvPr>
          <p:cNvGrpSpPr/>
          <p:nvPr/>
        </p:nvGrpSpPr>
        <p:grpSpPr>
          <a:xfrm>
            <a:off x="142874" y="304800"/>
            <a:ext cx="11391901" cy="5896462"/>
            <a:chOff x="123824" y="647700"/>
            <a:chExt cx="11391901" cy="5896462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71EBE35E-95C1-4983-A36D-83B3CB98A8B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2241" r="2181"/>
            <a:stretch/>
          </p:blipFill>
          <p:spPr>
            <a:xfrm>
              <a:off x="134224" y="819149"/>
              <a:ext cx="11210051" cy="5725013"/>
            </a:xfrm>
            <a:prstGeom prst="rect">
              <a:avLst/>
            </a:prstGeom>
          </p:spPr>
        </p:pic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5F5A586B-845D-45FE-BAF7-94FA560BCF46}"/>
                </a:ext>
              </a:extLst>
            </p:cNvPr>
            <p:cNvSpPr/>
            <p:nvPr/>
          </p:nvSpPr>
          <p:spPr>
            <a:xfrm>
              <a:off x="123824" y="647700"/>
              <a:ext cx="2752725" cy="28575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427E664F-8855-40F8-9666-6988E310A10A}"/>
                </a:ext>
              </a:extLst>
            </p:cNvPr>
            <p:cNvSpPr/>
            <p:nvPr/>
          </p:nvSpPr>
          <p:spPr>
            <a:xfrm>
              <a:off x="10858500" y="676274"/>
              <a:ext cx="657225" cy="42862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14D567DD-C7D7-4B1A-94B9-B3D456284881}"/>
              </a:ext>
            </a:extLst>
          </p:cNvPr>
          <p:cNvSpPr txBox="1"/>
          <p:nvPr/>
        </p:nvSpPr>
        <p:spPr>
          <a:xfrm>
            <a:off x="6096000" y="1095375"/>
            <a:ext cx="47625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3. 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positive mode REIMS spectra for a red bell pepper cultivar. 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9AC2011-ECAC-43F6-8709-E073E6FFCBE6}"/>
              </a:ext>
            </a:extLst>
          </p:cNvPr>
          <p:cNvSpPr txBox="1"/>
          <p:nvPr/>
        </p:nvSpPr>
        <p:spPr>
          <a:xfrm>
            <a:off x="4940936" y="6343650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/z</a:t>
            </a:r>
          </a:p>
        </p:txBody>
      </p:sp>
    </p:spTree>
    <p:extLst>
      <p:ext uri="{BB962C8B-B14F-4D97-AF65-F5344CB8AC3E}">
        <p14:creationId xmlns:p14="http://schemas.microsoft.com/office/powerpoint/2010/main" val="14149328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16</TotalTime>
  <Words>117</Words>
  <Application>Microsoft Office PowerPoint</Application>
  <PresentationFormat>Widescreen</PresentationFormat>
  <Paragraphs>17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>Water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istrator</dc:creator>
  <cp:lastModifiedBy>Prenni,Jessica</cp:lastModifiedBy>
  <cp:revision>11</cp:revision>
  <dcterms:created xsi:type="dcterms:W3CDTF">2020-11-20T23:49:16Z</dcterms:created>
  <dcterms:modified xsi:type="dcterms:W3CDTF">2021-03-14T23:57:08Z</dcterms:modified>
</cp:coreProperties>
</file>